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 userDrawn="1">
          <p15:clr>
            <a:srgbClr val="A4A3A4"/>
          </p15:clr>
        </p15:guide>
        <p15:guide id="2" pos="3742" userDrawn="1">
          <p15:clr>
            <a:srgbClr val="A4A3A4"/>
          </p15:clr>
        </p15:guide>
        <p15:guide id="3" orient="horz" pos="3044">
          <p15:clr>
            <a:srgbClr val="A4A3A4"/>
          </p15:clr>
        </p15:guide>
        <p15:guide id="4" pos="287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D9D9"/>
    <a:srgbClr val="FFCC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04" autoAdjust="0"/>
    <p:restoredTop sz="94660"/>
  </p:normalViewPr>
  <p:slideViewPr>
    <p:cSldViewPr snapToGrid="0" showGuides="1">
      <p:cViewPr varScale="1">
        <p:scale>
          <a:sx n="131" d="100"/>
          <a:sy n="131" d="100"/>
        </p:scale>
        <p:origin x="-800" y="-112"/>
      </p:cViewPr>
      <p:guideLst>
        <p:guide orient="horz" pos="2160"/>
        <p:guide orient="horz" pos="3044"/>
        <p:guide pos="3742"/>
        <p:guide pos="287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972767-5B8E-4143-A049-B73A0387EBDB}" type="datetimeFigureOut">
              <a:rPr lang="en-GB" smtClean="0"/>
              <a:pPr/>
              <a:t>27/07/17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9921EC6-34D4-4B7E-AC5E-A8CD7C23217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95865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6FFA99-95DE-4E01-B114-982B7CB05401}" type="datetime1">
              <a:rPr lang="en-GB" smtClean="0"/>
              <a:pPr/>
              <a:t>27/07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338705" y="6489990"/>
            <a:ext cx="805295" cy="365125"/>
          </a:xfrm>
        </p:spPr>
        <p:txBody>
          <a:bodyPr/>
          <a:lstStyle>
            <a:lvl1pPr>
              <a:defRPr sz="1600" b="1"/>
            </a:lvl1pPr>
          </a:lstStyle>
          <a:p>
            <a:fld id="{3AB6E0A9-1DFA-4628-96E6-71FCFC62308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3677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06802-87F6-4703-8F4C-ADA8684B78B9}" type="datetime1">
              <a:rPr lang="en-GB" smtClean="0"/>
              <a:pPr/>
              <a:t>27/07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6E0A9-1DFA-4628-96E6-71FCFC62308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37311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DC732F-D5D2-43B7-B0E6-037B5C7A3CF5}" type="datetime1">
              <a:rPr lang="en-GB" smtClean="0"/>
              <a:pPr/>
              <a:t>27/07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6E0A9-1DFA-4628-96E6-71FCFC62308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16696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37966-460C-4324-9BD3-A21C38071E22}" type="datetime1">
              <a:rPr lang="en-GB" smtClean="0"/>
              <a:pPr/>
              <a:t>27/07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6E0A9-1DFA-4628-96E6-71FCFC62308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47499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23C2C-924F-4E56-AF62-BEA9F20A4784}" type="datetime1">
              <a:rPr lang="en-GB" smtClean="0"/>
              <a:pPr/>
              <a:t>27/07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6E0A9-1DFA-4628-96E6-71FCFC62308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99327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96CCF8-25D2-4E75-B1F0-A42B1DEECFBE}" type="datetime1">
              <a:rPr lang="en-GB" smtClean="0"/>
              <a:pPr/>
              <a:t>27/07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6E0A9-1DFA-4628-96E6-71FCFC62308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50282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EAFAD-91FC-4E9C-805F-6CB1F9420482}" type="datetime1">
              <a:rPr lang="en-GB" smtClean="0"/>
              <a:pPr/>
              <a:t>27/07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6E0A9-1DFA-4628-96E6-71FCFC62308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17793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CF92-6151-4F26-A807-63437FDCD180}" type="datetime1">
              <a:rPr lang="en-GB" smtClean="0"/>
              <a:pPr/>
              <a:t>27/07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6E0A9-1DFA-4628-96E6-71FCFC62308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1707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3AA9B-CFED-4034-A369-C4318422B96F}" type="datetime1">
              <a:rPr lang="en-GB" smtClean="0"/>
              <a:pPr/>
              <a:t>27/07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6E0A9-1DFA-4628-96E6-71FCFC62308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22239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B3BB6-9C8A-4A59-9DD3-1D9DE0E19C51}" type="datetime1">
              <a:rPr lang="en-GB" smtClean="0"/>
              <a:pPr/>
              <a:t>27/07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6E0A9-1DFA-4628-96E6-71FCFC62308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21468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3BF1E-C8F2-4DE7-8175-2A9380DF4593}" type="datetime1">
              <a:rPr lang="en-GB" smtClean="0"/>
              <a:pPr/>
              <a:t>27/07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6E0A9-1DFA-4628-96E6-71FCFC62308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36930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FBB98E-1DCC-4E02-9A74-E849E30B1FE5}" type="datetime1">
              <a:rPr lang="en-GB" smtClean="0"/>
              <a:pPr/>
              <a:t>27/07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B6E0A9-1DFA-4628-96E6-71FCFC623084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50059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499764" y="6492875"/>
            <a:ext cx="644236" cy="365125"/>
          </a:xfrm>
        </p:spPr>
        <p:txBody>
          <a:bodyPr vert="horz" lIns="91440" tIns="45720" rIns="91440" bIns="45720" rtlCol="0" anchor="ctr"/>
          <a:lstStyle/>
          <a:p>
            <a:fld id="{3AB6E0A9-1DFA-4628-96E6-71FCFC623084}" type="slidenum">
              <a:rPr lang="en-GB" sz="1600">
                <a:solidFill>
                  <a:schemeClr val="bg1"/>
                </a:solidFill>
              </a:rPr>
              <a:pPr/>
              <a:t>1</a:t>
            </a:fld>
            <a:endParaRPr lang="en-GB" sz="1600">
              <a:solidFill>
                <a:schemeClr val="bg1"/>
              </a:solidFill>
            </a:endParaRPr>
          </a:p>
        </p:txBody>
      </p:sp>
      <p:grpSp>
        <p:nvGrpSpPr>
          <p:cNvPr id="2" name="Group 8"/>
          <p:cNvGrpSpPr/>
          <p:nvPr/>
        </p:nvGrpSpPr>
        <p:grpSpPr>
          <a:xfrm>
            <a:off x="0" y="2026132"/>
            <a:ext cx="9000219" cy="3703320"/>
            <a:chOff x="76047" y="1893432"/>
            <a:chExt cx="9000219" cy="3703320"/>
          </a:xfrm>
        </p:grpSpPr>
        <p:pic>
          <p:nvPicPr>
            <p:cNvPr id="1028" name="Picture 4" descr="X:\Research\Personal folders\Mr Cas\Other projects\Protein &amp; mutation modelling projects\CDK13\3D modeling\images\wt_surface_cycK_binding_site.png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047" y="1893432"/>
              <a:ext cx="4463415" cy="37033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29" name="Picture 5" descr="X:\Research\Personal folders\Mr Cas\Other projects\Protein &amp; mutation modelling projects\CDK13\3D modeling\images\R751Q_surface_cycK_binding_site.png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12851" y="1893432"/>
              <a:ext cx="4463415" cy="37033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TextBox 9"/>
            <p:cNvSpPr txBox="1"/>
            <p:nvPr/>
          </p:nvSpPr>
          <p:spPr>
            <a:xfrm>
              <a:off x="155070" y="2144715"/>
              <a:ext cx="110042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>
                  <a:solidFill>
                    <a:srgbClr val="CCFFCC"/>
                  </a:solidFill>
                </a:rPr>
                <a:t>CDK13 wt</a:t>
              </a:r>
              <a:endParaRPr lang="en-GB" dirty="0">
                <a:solidFill>
                  <a:srgbClr val="CCFFCC"/>
                </a:solidFill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550971" y="5095985"/>
              <a:ext cx="88222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err="1">
                  <a:solidFill>
                    <a:srgbClr val="FFD9D9"/>
                  </a:solidFill>
                </a:rPr>
                <a:t>cyclin</a:t>
              </a:r>
              <a:r>
                <a:rPr lang="en-GB" dirty="0">
                  <a:solidFill>
                    <a:srgbClr val="FFD9D9"/>
                  </a:solidFill>
                </a:rPr>
                <a:t> K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4708797" y="2144715"/>
              <a:ext cx="1489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>
                  <a:solidFill>
                    <a:srgbClr val="CCFFCC"/>
                  </a:solidFill>
                </a:rPr>
                <a:t>CDK13 R751Q</a:t>
              </a:r>
              <a:endParaRPr lang="en-GB" dirty="0">
                <a:solidFill>
                  <a:srgbClr val="CCFFCC"/>
                </a:solidFill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8093335" y="5095985"/>
              <a:ext cx="88222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err="1">
                  <a:solidFill>
                    <a:srgbClr val="FFD9D9"/>
                  </a:solidFill>
                </a:rPr>
                <a:t>cyclin</a:t>
              </a:r>
              <a:r>
                <a:rPr lang="en-GB" dirty="0">
                  <a:solidFill>
                    <a:srgbClr val="FFD9D9"/>
                  </a:solidFill>
                </a:rPr>
                <a:t> K</a:t>
              </a:r>
            </a:p>
          </p:txBody>
        </p:sp>
      </p:grpSp>
      <p:sp>
        <p:nvSpPr>
          <p:cNvPr id="23" name="TextBox 22"/>
          <p:cNvSpPr txBox="1"/>
          <p:nvPr/>
        </p:nvSpPr>
        <p:spPr>
          <a:xfrm>
            <a:off x="1" y="0"/>
            <a:ext cx="8892540" cy="14157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>
                <a:solidFill>
                  <a:schemeClr val="bg1"/>
                </a:solidFill>
              </a:rPr>
              <a:t>S7 </a:t>
            </a:r>
            <a:r>
              <a:rPr lang="en-GB" sz="1600" smtClean="0">
                <a:solidFill>
                  <a:schemeClr val="bg1"/>
                </a:solidFill>
              </a:rPr>
              <a:t>Supplementary image: </a:t>
            </a:r>
            <a:r>
              <a:rPr lang="en-GB" sz="1600" dirty="0" smtClean="0">
                <a:solidFill>
                  <a:schemeClr val="bg1"/>
                </a:solidFill>
              </a:rPr>
              <a:t>CDK13-cyclin </a:t>
            </a:r>
            <a:r>
              <a:rPr lang="en-GB" sz="1600" dirty="0">
                <a:solidFill>
                  <a:schemeClr val="bg1"/>
                </a:solidFill>
              </a:rPr>
              <a:t>K complex – effect of </a:t>
            </a:r>
            <a:r>
              <a:rPr lang="en-GB" sz="1600" dirty="0" smtClean="0">
                <a:solidFill>
                  <a:schemeClr val="bg1"/>
                </a:solidFill>
              </a:rPr>
              <a:t>Arg751Gln </a:t>
            </a:r>
            <a:r>
              <a:rPr lang="en-GB" sz="1600" dirty="0">
                <a:solidFill>
                  <a:schemeClr val="bg1"/>
                </a:solidFill>
              </a:rPr>
              <a:t>variant </a:t>
            </a:r>
            <a:r>
              <a:rPr lang="en-GB" sz="1600" dirty="0" smtClean="0">
                <a:solidFill>
                  <a:schemeClr val="bg1"/>
                </a:solidFill>
              </a:rPr>
              <a:t>[2]</a:t>
            </a:r>
            <a:endParaRPr lang="en-GB" sz="1600" dirty="0">
              <a:solidFill>
                <a:schemeClr val="bg1"/>
              </a:solidFill>
            </a:endParaRPr>
          </a:p>
          <a:p>
            <a:pPr lvl="1"/>
            <a:r>
              <a:rPr lang="en-GB" sz="1400" dirty="0" smtClean="0">
                <a:solidFill>
                  <a:schemeClr val="bg1"/>
                </a:solidFill>
              </a:rPr>
              <a:t>The surface of CDK13 wt (left) or Arg751Gln (right) is coloured green, except for residues which form the interface with cyclin K, which are shown in shades of blue: residue 751 is coloured dark blue; other residues within the PITAIRE motif are coloured pale turquoise, while residues lying outside the PITAIRE motif are coloured light blue; the bound ADP ligand is coloured orange. In both panels, cyclin K is shown in ribbon format, with the sidechain of Asp108, which hydrogen bonds to CDK13 residue 751, shown in stick format.</a:t>
            </a:r>
            <a:endParaRPr lang="en-GB" sz="14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0848051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35</TotalTime>
  <Words>131</Words>
  <Application>Microsoft Macintosh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chard Caswell</dc:creator>
  <cp:lastModifiedBy>Mark Hamilton</cp:lastModifiedBy>
  <cp:revision>52</cp:revision>
  <dcterms:created xsi:type="dcterms:W3CDTF">2016-10-30T14:31:13Z</dcterms:created>
  <dcterms:modified xsi:type="dcterms:W3CDTF">2017-07-27T17:47:03Z</dcterms:modified>
</cp:coreProperties>
</file>